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0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1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/>
    <p:restoredTop sz="92017"/>
  </p:normalViewPr>
  <p:slideViewPr>
    <p:cSldViewPr snapToGrid="0">
      <p:cViewPr>
        <p:scale>
          <a:sx n="100" d="100"/>
          <a:sy n="100" d="100"/>
        </p:scale>
        <p:origin x="2896" y="-440"/>
      </p:cViewPr>
      <p:guideLst>
        <p:guide orient="horz" pos="2621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9F04B6-F912-E44D-B4F8-91F0A27773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9185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C65C54-EC46-1978-4213-064952271443}"/>
              </a:ext>
            </a:extLst>
          </p:cNvPr>
          <p:cNvSpPr txBox="1"/>
          <p:nvPr/>
        </p:nvSpPr>
        <p:spPr>
          <a:xfrm>
            <a:off x="70000" y="44354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8B6A46B-2D31-424F-D453-21B33C3ED422}"/>
              </a:ext>
            </a:extLst>
          </p:cNvPr>
          <p:cNvSpPr txBox="1"/>
          <p:nvPr/>
        </p:nvSpPr>
        <p:spPr>
          <a:xfrm>
            <a:off x="62743" y="22155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7327984-9BE0-9BC0-4A1C-C59929A97BC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87" b="7623"/>
          <a:stretch/>
        </p:blipFill>
        <p:spPr>
          <a:xfrm>
            <a:off x="778751" y="2463077"/>
            <a:ext cx="1269057" cy="12071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661E23F-6D1F-B300-4285-409A1CF91DF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187" b="7623"/>
          <a:stretch/>
        </p:blipFill>
        <p:spPr>
          <a:xfrm>
            <a:off x="2047808" y="2468047"/>
            <a:ext cx="1269058" cy="12071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DD7AF12-1886-2124-C150-3D08BB917A4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608" b="6113"/>
          <a:stretch/>
        </p:blipFill>
        <p:spPr>
          <a:xfrm>
            <a:off x="3316866" y="2477185"/>
            <a:ext cx="1276969" cy="122687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19F5FF8-9A90-336C-C0B5-6B9ADDCD07E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608" b="6346"/>
          <a:stretch/>
        </p:blipFill>
        <p:spPr>
          <a:xfrm>
            <a:off x="4617172" y="2477185"/>
            <a:ext cx="1276970" cy="1223834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ED8494B-111E-C27C-E2B7-1EAE61D3FC99}"/>
              </a:ext>
            </a:extLst>
          </p:cNvPr>
          <p:cNvCxnSpPr/>
          <p:nvPr/>
        </p:nvCxnSpPr>
        <p:spPr>
          <a:xfrm flipV="1">
            <a:off x="732648" y="3381768"/>
            <a:ext cx="0" cy="28610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E02E0A7-9D1B-EB52-1876-84A55B280E69}"/>
              </a:ext>
            </a:extLst>
          </p:cNvPr>
          <p:cNvCxnSpPr/>
          <p:nvPr/>
        </p:nvCxnSpPr>
        <p:spPr>
          <a:xfrm>
            <a:off x="732648" y="3667869"/>
            <a:ext cx="28085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41F84AC-21D2-9B02-2961-CD78EC0771D8}"/>
              </a:ext>
            </a:extLst>
          </p:cNvPr>
          <p:cNvSpPr txBox="1"/>
          <p:nvPr/>
        </p:nvSpPr>
        <p:spPr>
          <a:xfrm rot="16200000">
            <a:off x="349850" y="3417096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FT blu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D880B12-FDFD-7452-EF8F-8299F0E662B5}"/>
              </a:ext>
            </a:extLst>
          </p:cNvPr>
          <p:cNvSpPr txBox="1"/>
          <p:nvPr/>
        </p:nvSpPr>
        <p:spPr>
          <a:xfrm>
            <a:off x="623647" y="371519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FT red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FBA4E3C-B915-14DF-4B44-F8620FE67A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823784"/>
            <a:ext cx="4258867" cy="133128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32FA46C-7CCF-E1B3-8307-CB058A92DF8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52895" y="354227"/>
            <a:ext cx="1885354" cy="184418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5D2FA78-2A91-780A-0E22-73CD7A648464}"/>
              </a:ext>
            </a:extLst>
          </p:cNvPr>
          <p:cNvSpPr txBox="1"/>
          <p:nvPr/>
        </p:nvSpPr>
        <p:spPr>
          <a:xfrm>
            <a:off x="1196217" y="2249049"/>
            <a:ext cx="93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Vehicl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847B16-42CC-400A-26CF-20809D795E68}"/>
              </a:ext>
            </a:extLst>
          </p:cNvPr>
          <p:cNvSpPr txBox="1"/>
          <p:nvPr/>
        </p:nvSpPr>
        <p:spPr>
          <a:xfrm>
            <a:off x="2362251" y="2244340"/>
            <a:ext cx="93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/>
              <a:t>Xevinapant</a:t>
            </a:r>
            <a:endParaRPr lang="en-US" sz="11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D77660B-B28C-5CEF-8747-9B304AC43E3D}"/>
              </a:ext>
            </a:extLst>
          </p:cNvPr>
          <p:cNvSpPr txBox="1"/>
          <p:nvPr/>
        </p:nvSpPr>
        <p:spPr>
          <a:xfrm>
            <a:off x="3572837" y="2250073"/>
            <a:ext cx="93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RT + vehicl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F29F31-739B-47EA-1315-38C82A75FC5C}"/>
              </a:ext>
            </a:extLst>
          </p:cNvPr>
          <p:cNvSpPr txBox="1"/>
          <p:nvPr/>
        </p:nvSpPr>
        <p:spPr>
          <a:xfrm>
            <a:off x="4742536" y="2250300"/>
            <a:ext cx="12769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RT + </a:t>
            </a:r>
            <a:r>
              <a:rPr lang="en-US" sz="1100" dirty="0" err="1"/>
              <a:t>xevinapant</a:t>
            </a:r>
            <a:endParaRPr lang="en-US" sz="11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975EA28-A2E8-862B-7A19-943DF7EB0EA7}"/>
              </a:ext>
            </a:extLst>
          </p:cNvPr>
          <p:cNvSpPr txBox="1"/>
          <p:nvPr/>
        </p:nvSpPr>
        <p:spPr>
          <a:xfrm>
            <a:off x="4162399" y="43822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8EB399E-29F7-8C02-5DC7-805A76EFDD88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50DCD96-25F0-E4FE-F0D8-53A7190ED891}"/>
              </a:ext>
            </a:extLst>
          </p:cNvPr>
          <p:cNvSpPr txBox="1"/>
          <p:nvPr/>
        </p:nvSpPr>
        <p:spPr>
          <a:xfrm>
            <a:off x="374763" y="4092862"/>
            <a:ext cx="601774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The Nr4a3-Tocky system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Nr4a3 is rapidly transcribed in response to T-cell receptor (TCR) activation, which drives the transcription of the Fluorescent Timer (FT) protein that decays from blue to red with relatively short half-life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low cytometric analysis of T-cells whereby “new” are T-cells who have recently encountered their antigen with recent TCR signals (FT blue+), “persistent” are T-cells with frequent antigen recognition with persistent TCR signals (FT blue+ red+) and “arrested” are T-cells who have infrequent encounter with antigen with historical TCR signals (FT red+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ating strategy example of CD8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-cells showing percentages of different Timer populations across different treatment conditions.</a:t>
            </a:r>
          </a:p>
        </p:txBody>
      </p:sp>
    </p:spTree>
    <p:extLst>
      <p:ext uri="{BB962C8B-B14F-4D97-AF65-F5344CB8AC3E}">
        <p14:creationId xmlns:p14="http://schemas.microsoft.com/office/powerpoint/2010/main" val="2361675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3</TotalTime>
  <Words>150</Words>
  <Application>Microsoft Macintosh PowerPoint</Application>
  <PresentationFormat>A4 Paper (210x297 mm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536</cp:revision>
  <cp:lastPrinted>2025-06-25T15:47:08Z</cp:lastPrinted>
  <dcterms:created xsi:type="dcterms:W3CDTF">2019-11-04T10:33:30Z</dcterms:created>
  <dcterms:modified xsi:type="dcterms:W3CDTF">2025-10-09T08:54:49Z</dcterms:modified>
</cp:coreProperties>
</file>